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142" autoAdjust="0"/>
  </p:normalViewPr>
  <p:slideViewPr>
    <p:cSldViewPr snapToGrid="0">
      <p:cViewPr>
        <p:scale>
          <a:sx n="150" d="100"/>
          <a:sy n="150" d="100"/>
        </p:scale>
        <p:origin x="-768" y="-72"/>
      </p:cViewPr>
      <p:guideLst>
        <p:guide orient="horz" pos="2880"/>
        <p:guide pos="3132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86B55A-1642-41A0-9291-C5CFD1A80D6A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DEB582-E75E-4700-9E01-481FCB63F0F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92238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9153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34608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6738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7747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4755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0261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44883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69213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1348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958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9958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19D8F-5631-42E2-B45D-2F495C29DD1C}" type="datetimeFigureOut">
              <a:rPr lang="de-CH" smtClean="0"/>
              <a:t>24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93072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643" y="4607902"/>
            <a:ext cx="2742996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272" y="4606987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643" y="2754073"/>
            <a:ext cx="2743910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9" name="Picture 289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643" y="1139549"/>
            <a:ext cx="2728004" cy="1506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7" name="Picture 28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272" y="1142208"/>
            <a:ext cx="2728004" cy="1506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74485" y="97657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484563" y="976574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0648" y="267976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70725" y="267976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60648" y="4454587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470726" y="4454587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56794" y="91212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797154" y="91212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29"/>
          <p:cNvSpPr txBox="1"/>
          <p:nvPr/>
        </p:nvSpPr>
        <p:spPr>
          <a:xfrm rot="16200000">
            <a:off x="-140384" y="1842277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ematocrit  (%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29"/>
          <p:cNvSpPr txBox="1"/>
          <p:nvPr/>
        </p:nvSpPr>
        <p:spPr>
          <a:xfrm rot="16200000">
            <a:off x="-131070" y="3437532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CV (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800" dirty="0" smtClean="0"/>
              <a:t>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29"/>
          <p:cNvSpPr txBox="1"/>
          <p:nvPr/>
        </p:nvSpPr>
        <p:spPr>
          <a:xfrm rot="16200000">
            <a:off x="-131070" y="516572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CHC (g/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sz="800" dirty="0" smtClean="0"/>
              <a:t>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29"/>
          <p:cNvSpPr txBox="1"/>
          <p:nvPr/>
        </p:nvSpPr>
        <p:spPr>
          <a:xfrm rot="16200000">
            <a:off x="3037282" y="1842277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ematocrit (%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429"/>
          <p:cNvSpPr txBox="1"/>
          <p:nvPr/>
        </p:nvSpPr>
        <p:spPr>
          <a:xfrm rot="16200000">
            <a:off x="3046594" y="3437532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CV (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429"/>
          <p:cNvSpPr txBox="1"/>
          <p:nvPr/>
        </p:nvSpPr>
        <p:spPr>
          <a:xfrm rot="16200000">
            <a:off x="3046594" y="516572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CHC (g/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sz="800" dirty="0" smtClean="0"/>
              <a:t>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601"/>
          <p:cNvSpPr txBox="1"/>
          <p:nvPr/>
        </p:nvSpPr>
        <p:spPr>
          <a:xfrm>
            <a:off x="959096" y="6210430"/>
            <a:ext cx="19746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h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601"/>
          <p:cNvSpPr txBox="1"/>
          <p:nvPr/>
        </p:nvSpPr>
        <p:spPr>
          <a:xfrm>
            <a:off x="4161162" y="6210430"/>
            <a:ext cx="19919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h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836712" y="184269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836712" y="1391842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043462" y="184269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043462" y="1391842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026793" y="3782220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043462" y="347265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845162" y="534312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838588" y="5001816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43462" y="534392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4064893" y="504745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/>
          <p:cNvGrpSpPr/>
          <p:nvPr/>
        </p:nvGrpSpPr>
        <p:grpSpPr>
          <a:xfrm>
            <a:off x="1143364" y="1330361"/>
            <a:ext cx="261204" cy="276999"/>
            <a:chOff x="1143364" y="603283"/>
            <a:chExt cx="261204" cy="276999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1143364" y="754758"/>
              <a:ext cx="261204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1147754" y="603283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CH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272" y="2754073"/>
            <a:ext cx="2742996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0" name="Straight Connector 79"/>
          <p:cNvCxnSpPr/>
          <p:nvPr/>
        </p:nvCxnSpPr>
        <p:spPr>
          <a:xfrm>
            <a:off x="824012" y="3782220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840681" y="347265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3" name="Group 82"/>
          <p:cNvGrpSpPr/>
          <p:nvPr/>
        </p:nvGrpSpPr>
        <p:grpSpPr>
          <a:xfrm>
            <a:off x="1187450" y="2898621"/>
            <a:ext cx="401491" cy="276999"/>
            <a:chOff x="1162186" y="603283"/>
            <a:chExt cx="401491" cy="276999"/>
          </a:xfrm>
        </p:grpSpPr>
        <p:cxnSp>
          <p:nvCxnSpPr>
            <p:cNvPr id="85" name="Straight Connector 84"/>
            <p:cNvCxnSpPr/>
            <p:nvPr/>
          </p:nvCxnSpPr>
          <p:spPr>
            <a:xfrm>
              <a:off x="1162186" y="754758"/>
              <a:ext cx="401491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1226327" y="603283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CH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1165274" y="4697912"/>
            <a:ext cx="199216" cy="276999"/>
            <a:chOff x="1112895" y="603283"/>
            <a:chExt cx="291673" cy="276999"/>
          </a:xfrm>
        </p:grpSpPr>
        <p:cxnSp>
          <p:nvCxnSpPr>
            <p:cNvPr id="89" name="Straight Connector 88"/>
            <p:cNvCxnSpPr/>
            <p:nvPr/>
          </p:nvCxnSpPr>
          <p:spPr>
            <a:xfrm>
              <a:off x="1143364" y="754758"/>
              <a:ext cx="261204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1112895" y="603283"/>
              <a:ext cx="243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CH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4748774" y="134972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19131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</dc:creator>
  <cp:lastModifiedBy>Regina Hofmann</cp:lastModifiedBy>
  <cp:revision>211</cp:revision>
  <cp:lastPrinted>2015-04-09T09:13:44Z</cp:lastPrinted>
  <dcterms:created xsi:type="dcterms:W3CDTF">2013-01-23T18:37:05Z</dcterms:created>
  <dcterms:modified xsi:type="dcterms:W3CDTF">2015-07-24T05:40:43Z</dcterms:modified>
</cp:coreProperties>
</file>